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7" r:id="rId2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1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98"/>
    <p:restoredTop sz="94574"/>
  </p:normalViewPr>
  <p:slideViewPr>
    <p:cSldViewPr snapToGrid="0" snapToObjects="1" showGuides="1">
      <p:cViewPr varScale="1">
        <p:scale>
          <a:sx n="91" d="100"/>
          <a:sy n="91" d="100"/>
        </p:scale>
        <p:origin x="200" y="704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EBFB23-8B90-1C4C-83A6-A560B664F6BD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744DF7-7E64-6D46-9343-46E4DBCD06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56251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D744DF7-7E64-6D46-9343-46E4DBCD06E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41968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5780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6589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92996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1549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60679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92014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39653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8592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14670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1669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97707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1369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471D9888-CC33-644F-8FED-2A74310EED60}"/>
              </a:ext>
            </a:extLst>
          </p:cNvPr>
          <p:cNvSpPr/>
          <p:nvPr/>
        </p:nvSpPr>
        <p:spPr>
          <a:xfrm>
            <a:off x="546411" y="1370593"/>
            <a:ext cx="3129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dirty="0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12239042-7868-AB42-A5BF-DBBBFA527A23}"/>
              </a:ext>
            </a:extLst>
          </p:cNvPr>
          <p:cNvSpPr/>
          <p:nvPr/>
        </p:nvSpPr>
        <p:spPr>
          <a:xfrm>
            <a:off x="5085482" y="1370593"/>
            <a:ext cx="3257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dirty="0"/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B78754D5-1B40-1F43-9D91-03139C093855}"/>
              </a:ext>
            </a:extLst>
          </p:cNvPr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246"/>
          <a:stretch/>
        </p:blipFill>
        <p:spPr bwMode="auto">
          <a:xfrm>
            <a:off x="546411" y="1670674"/>
            <a:ext cx="4378462" cy="3217692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11E8DF7-4698-6540-A66F-EDA3BF3F41D7}"/>
              </a:ext>
            </a:extLst>
          </p:cNvPr>
          <p:cNvSpPr txBox="1"/>
          <p:nvPr/>
        </p:nvSpPr>
        <p:spPr>
          <a:xfrm>
            <a:off x="735764" y="5595228"/>
            <a:ext cx="8699435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7: Figure </a:t>
            </a:r>
            <a:r>
              <a:rPr lang="en-US" altLang="ja-JP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. Forest plot of 1-year (a) and 2-year (b) PFS with doxorubicin alone vs experimental chemotherapy. </a:t>
            </a:r>
          </a:p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bbreviations: CI, confidence interval; M-H, Mantel-</a:t>
            </a:r>
            <a:r>
              <a:rPr lang="en-US" altLang="ja-JP" sz="1600" dirty="0" err="1">
                <a:latin typeface="Arial" panose="020B0604020202020204" pitchFamily="34" charset="0"/>
                <a:cs typeface="Arial" panose="020B0604020202020204" pitchFamily="34" charset="0"/>
              </a:rPr>
              <a:t>Haenszel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; PFS, progression-free survival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657323D0-0D2E-3E46-ABF9-B5A91B1C23D8}"/>
              </a:ext>
            </a:extLst>
          </p:cNvPr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3167"/>
          <a:stretch/>
        </p:blipFill>
        <p:spPr bwMode="auto">
          <a:xfrm>
            <a:off x="5085481" y="1670674"/>
            <a:ext cx="4369112" cy="3018406"/>
          </a:xfrm>
          <a:prstGeom prst="rect">
            <a:avLst/>
          </a:prstGeom>
          <a:solidFill>
            <a:schemeClr val="bg1"/>
          </a:solidFill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4090520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</TotalTime>
  <Words>45</Words>
  <Application>Microsoft Macintosh PowerPoint</Application>
  <PresentationFormat>A4 210 x 297 mm</PresentationFormat>
  <Paragraphs>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/>
  <cp:lastModifiedBy>田仲和宏</cp:lastModifiedBy>
  <cp:revision>37</cp:revision>
  <cp:lastPrinted>2018-06-08T06:33:36Z</cp:lastPrinted>
  <dcterms:created xsi:type="dcterms:W3CDTF">2018-05-19T00:24:53Z</dcterms:created>
  <dcterms:modified xsi:type="dcterms:W3CDTF">2018-12-11T05:04:54Z</dcterms:modified>
</cp:coreProperties>
</file>